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4660"/>
  </p:normalViewPr>
  <p:slideViewPr>
    <p:cSldViewPr snapToGrid="0">
      <p:cViewPr varScale="1">
        <p:scale>
          <a:sx n="75" d="100"/>
          <a:sy n="75" d="100"/>
        </p:scale>
        <p:origin x="90" y="8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lal, Prarthana" userId="4c2b75d5-54dc-4060-9b70-9bfe12281fe7" providerId="ADAL" clId="{83F5F05C-8E26-40C9-90F1-3A3EA35CB487}"/>
    <pc:docChg chg="custSel delSld modSld">
      <pc:chgData name="Dalal, Prarthana" userId="4c2b75d5-54dc-4060-9b70-9bfe12281fe7" providerId="ADAL" clId="{83F5F05C-8E26-40C9-90F1-3A3EA35CB487}" dt="2025-11-14T14:46:23.362" v="3" actId="47"/>
      <pc:docMkLst>
        <pc:docMk/>
      </pc:docMkLst>
      <pc:sldChg chg="delSp mod">
        <pc:chgData name="Dalal, Prarthana" userId="4c2b75d5-54dc-4060-9b70-9bfe12281fe7" providerId="ADAL" clId="{83F5F05C-8E26-40C9-90F1-3A3EA35CB487}" dt="2025-11-14T14:46:14.823" v="0" actId="478"/>
        <pc:sldMkLst>
          <pc:docMk/>
          <pc:sldMk cId="1991306670" sldId="256"/>
        </pc:sldMkLst>
        <pc:grpChg chg="del">
          <ac:chgData name="Dalal, Prarthana" userId="4c2b75d5-54dc-4060-9b70-9bfe12281fe7" providerId="ADAL" clId="{83F5F05C-8E26-40C9-90F1-3A3EA35CB487}" dt="2025-11-14T14:46:14.823" v="0" actId="478"/>
          <ac:grpSpMkLst>
            <pc:docMk/>
            <pc:sldMk cId="1991306670" sldId="256"/>
            <ac:grpSpMk id="8" creationId="{00000000-0000-0000-0000-000000000000}"/>
          </ac:grpSpMkLst>
        </pc:grpChg>
      </pc:sldChg>
      <pc:sldChg chg="delSp del mod">
        <pc:chgData name="Dalal, Prarthana" userId="4c2b75d5-54dc-4060-9b70-9bfe12281fe7" providerId="ADAL" clId="{83F5F05C-8E26-40C9-90F1-3A3EA35CB487}" dt="2025-11-14T14:46:22.355" v="2" actId="47"/>
        <pc:sldMkLst>
          <pc:docMk/>
          <pc:sldMk cId="3831981878" sldId="259"/>
        </pc:sldMkLst>
        <pc:picChg chg="del">
          <ac:chgData name="Dalal, Prarthana" userId="4c2b75d5-54dc-4060-9b70-9bfe12281fe7" providerId="ADAL" clId="{83F5F05C-8E26-40C9-90F1-3A3EA35CB487}" dt="2025-11-14T14:46:20.683" v="1" actId="478"/>
          <ac:picMkLst>
            <pc:docMk/>
            <pc:sldMk cId="3831981878" sldId="259"/>
            <ac:picMk id="4" creationId="{E081EAB8-BB5D-8233-34D6-4548EDFC5594}"/>
          </ac:picMkLst>
        </pc:picChg>
      </pc:sldChg>
      <pc:sldChg chg="del">
        <pc:chgData name="Dalal, Prarthana" userId="4c2b75d5-54dc-4060-9b70-9bfe12281fe7" providerId="ADAL" clId="{83F5F05C-8E26-40C9-90F1-3A3EA35CB487}" dt="2025-11-14T14:46:23.362" v="3" actId="47"/>
        <pc:sldMkLst>
          <pc:docMk/>
          <pc:sldMk cId="2330030882" sldId="26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96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425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38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757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193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938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350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129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419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62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371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003E9-D3AA-43CB-993D-DF911B889106}" type="datetimeFigureOut">
              <a:rPr lang="en-US" smtClean="0"/>
              <a:t>1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11076-483E-4785-82CF-D77108081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288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2542330" y="208807"/>
            <a:ext cx="6098525" cy="2790856"/>
            <a:chOff x="2484864" y="518567"/>
            <a:chExt cx="6098525" cy="2790856"/>
          </a:xfrm>
        </p:grpSpPr>
        <p:sp>
          <p:nvSpPr>
            <p:cNvPr id="10" name="TextBox 9"/>
            <p:cNvSpPr txBox="1"/>
            <p:nvPr/>
          </p:nvSpPr>
          <p:spPr>
            <a:xfrm>
              <a:off x="2858206" y="2097226"/>
              <a:ext cx="7328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IN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F-2</a:t>
              </a:r>
              <a:r>
                <a:rPr lang="el-GR" sz="1400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879045" y="2691696"/>
              <a:ext cx="7457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N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282822" y="839575"/>
              <a:ext cx="1193618" cy="1044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</a:p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Scrambled</a:t>
              </a:r>
            </a:p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                                </a:t>
              </a:r>
            </a:p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3591099" y="1753987"/>
              <a:ext cx="1228874" cy="0"/>
            </a:xfrm>
            <a:prstGeom prst="line">
              <a:avLst/>
            </a:prstGeom>
            <a:noFill/>
            <a:ln w="31750" cap="flat" cmpd="sng" algn="ctr">
              <a:solidFill>
                <a:schemeClr val="tx1">
                  <a:lumMod val="75000"/>
                  <a:lumOff val="25000"/>
                </a:schemeClr>
              </a:solidFill>
              <a:prstDash val="solid"/>
              <a:miter lim="800000"/>
            </a:ln>
            <a:effectLst/>
          </p:spPr>
        </p:cxnSp>
        <p:cxnSp>
          <p:nvCxnSpPr>
            <p:cNvPr id="24" name="Straight Connector 23"/>
            <p:cNvCxnSpPr/>
            <p:nvPr/>
          </p:nvCxnSpPr>
          <p:spPr>
            <a:xfrm>
              <a:off x="4879631" y="1753987"/>
              <a:ext cx="1122284" cy="0"/>
            </a:xfrm>
            <a:prstGeom prst="line">
              <a:avLst/>
            </a:prstGeom>
            <a:noFill/>
            <a:ln w="31750" cap="flat" cmpd="sng" algn="ctr">
              <a:solidFill>
                <a:schemeClr val="tx1">
                  <a:lumMod val="75000"/>
                  <a:lumOff val="25000"/>
                </a:schemeClr>
              </a:solidFill>
              <a:prstDash val="solid"/>
              <a:miter lim="800000"/>
            </a:ln>
            <a:effectLst/>
          </p:spPr>
        </p:cxnSp>
        <p:sp>
          <p:nvSpPr>
            <p:cNvPr id="26" name="TextBox 25"/>
            <p:cNvSpPr txBox="1"/>
            <p:nvPr/>
          </p:nvSpPr>
          <p:spPr>
            <a:xfrm>
              <a:off x="6523599" y="1207533"/>
              <a:ext cx="1371600" cy="6638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HIF-2</a:t>
              </a:r>
              <a:r>
                <a:rPr lang="el-GR" sz="1238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KO                                                              </a:t>
              </a:r>
            </a:p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                                </a:t>
              </a:r>
            </a:p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529937" y="518567"/>
              <a:ext cx="1097280" cy="1044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</a:p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SW480 cells                                                            </a:t>
              </a:r>
            </a:p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                                </a:t>
              </a:r>
            </a:p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484864" y="1100838"/>
              <a:ext cx="5852160" cy="85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               </a:t>
              </a:r>
            </a:p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                                 </a:t>
              </a:r>
            </a:p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vehicle                FG4592                 vehicle              FG4592       </a:t>
              </a:r>
            </a:p>
            <a:p>
              <a:pPr defTabSz="514350">
                <a:defRPr/>
              </a:pPr>
              <a:r>
                <a:rPr lang="en-US" sz="1238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79" t="45280" r="22776" b="43162"/>
            <a:stretch/>
          </p:blipFill>
          <p:spPr>
            <a:xfrm>
              <a:off x="3556431" y="1900413"/>
              <a:ext cx="4999455" cy="603054"/>
            </a:xfrm>
            <a:prstGeom prst="rect">
              <a:avLst/>
            </a:prstGeom>
            <a:ln w="19050">
              <a:solidFill>
                <a:schemeClr val="tx1">
                  <a:lumMod val="85000"/>
                  <a:lumOff val="15000"/>
                </a:schemeClr>
              </a:solidFill>
            </a:ln>
          </p:spPr>
        </p:pic>
        <p:cxnSp>
          <p:nvCxnSpPr>
            <p:cNvPr id="31" name="Straight Connector 30"/>
            <p:cNvCxnSpPr/>
            <p:nvPr/>
          </p:nvCxnSpPr>
          <p:spPr>
            <a:xfrm>
              <a:off x="6147908" y="1753987"/>
              <a:ext cx="1122284" cy="0"/>
            </a:xfrm>
            <a:prstGeom prst="line">
              <a:avLst/>
            </a:prstGeom>
            <a:noFill/>
            <a:ln w="31750" cap="flat" cmpd="sng" algn="ctr">
              <a:solidFill>
                <a:schemeClr val="tx1">
                  <a:lumMod val="75000"/>
                  <a:lumOff val="25000"/>
                </a:schemeClr>
              </a:solidFill>
              <a:prstDash val="solid"/>
              <a:miter lim="800000"/>
            </a:ln>
            <a:effectLst/>
          </p:spPr>
        </p:cxnSp>
        <p:cxnSp>
          <p:nvCxnSpPr>
            <p:cNvPr id="32" name="Straight Connector 31"/>
            <p:cNvCxnSpPr/>
            <p:nvPr/>
          </p:nvCxnSpPr>
          <p:spPr>
            <a:xfrm>
              <a:off x="7324442" y="1753987"/>
              <a:ext cx="1122284" cy="0"/>
            </a:xfrm>
            <a:prstGeom prst="line">
              <a:avLst/>
            </a:prstGeom>
            <a:noFill/>
            <a:ln w="31750" cap="flat" cmpd="sng" algn="ctr">
              <a:solidFill>
                <a:schemeClr val="tx1">
                  <a:lumMod val="75000"/>
                  <a:lumOff val="25000"/>
                </a:schemeClr>
              </a:solidFill>
              <a:prstDash val="solid"/>
              <a:miter lim="800000"/>
            </a:ln>
            <a:effectLst/>
          </p:spPr>
        </p:cxnSp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763" t="33444" r="17843" b="55469"/>
            <a:stretch/>
          </p:blipFill>
          <p:spPr>
            <a:xfrm>
              <a:off x="3573764" y="2599115"/>
              <a:ext cx="5009625" cy="573437"/>
            </a:xfrm>
            <a:prstGeom prst="rect">
              <a:avLst/>
            </a:prstGeom>
            <a:ln w="19050">
              <a:solidFill>
                <a:schemeClr val="tx1">
                  <a:lumMod val="85000"/>
                  <a:lumOff val="15000"/>
                </a:schemeClr>
              </a:solidFill>
            </a:ln>
          </p:spPr>
        </p:pic>
        <p:cxnSp>
          <p:nvCxnSpPr>
            <p:cNvPr id="5" name="Straight Connector 4"/>
            <p:cNvCxnSpPr/>
            <p:nvPr/>
          </p:nvCxnSpPr>
          <p:spPr>
            <a:xfrm>
              <a:off x="6032942" y="1663503"/>
              <a:ext cx="0" cy="1645920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913066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FDE93E6-892F-857A-76FD-D7D0DD3C7275}"/>
              </a:ext>
            </a:extLst>
          </p:cNvPr>
          <p:cNvSpPr txBox="1"/>
          <p:nvPr/>
        </p:nvSpPr>
        <p:spPr>
          <a:xfrm>
            <a:off x="4419002" y="137687"/>
            <a:ext cx="4145878" cy="8543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14350">
              <a:defRPr/>
            </a:pPr>
            <a:r>
              <a:rPr lang="en-US" sz="1238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</a:p>
          <a:p>
            <a:pPr defTabSz="514350">
              <a:defRPr/>
            </a:pPr>
            <a:r>
              <a:rPr lang="en-US" sz="1238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Raw images- SW HIF2                                                            </a:t>
            </a:r>
          </a:p>
          <a:p>
            <a:pPr defTabSz="514350">
              <a:defRPr/>
            </a:pPr>
            <a:r>
              <a:rPr lang="en-US" sz="1238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      </a:t>
            </a:r>
          </a:p>
          <a:p>
            <a:pPr defTabSz="514350">
              <a:defRPr/>
            </a:pPr>
            <a:r>
              <a:rPr lang="en-US" sz="1238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</a:p>
        </p:txBody>
      </p:sp>
      <p:pic>
        <p:nvPicPr>
          <p:cNvPr id="4" name="Picture 3" descr="A close-up of a test&#10;&#10;AI-generated content may be incorrect.">
            <a:extLst>
              <a:ext uri="{FF2B5EF4-FFF2-40B4-BE49-F238E27FC236}">
                <a16:creationId xmlns:a16="http://schemas.microsoft.com/office/drawing/2014/main" id="{A58487EA-A042-ADF5-7AB7-FFBB247401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062" y="842962"/>
            <a:ext cx="7381875" cy="5172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82136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line on a white background&#10;&#10;AI-generated content may be incorrect.">
            <a:extLst>
              <a:ext uri="{FF2B5EF4-FFF2-40B4-BE49-F238E27FC236}">
                <a16:creationId xmlns:a16="http://schemas.microsoft.com/office/drawing/2014/main" id="{0BCEBE8D-517E-61B8-747E-EB0AADF531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5062" y="842962"/>
            <a:ext cx="7381875" cy="517207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737143F-11B6-524E-743C-EE25E2CF28AB}"/>
              </a:ext>
            </a:extLst>
          </p:cNvPr>
          <p:cNvSpPr txBox="1"/>
          <p:nvPr/>
        </p:nvSpPr>
        <p:spPr>
          <a:xfrm>
            <a:off x="4419002" y="137687"/>
            <a:ext cx="4145878" cy="8543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14350">
              <a:defRPr/>
            </a:pPr>
            <a:r>
              <a:rPr lang="en-US" sz="1238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</a:p>
          <a:p>
            <a:pPr defTabSz="514350">
              <a:defRPr/>
            </a:pPr>
            <a:r>
              <a:rPr lang="en-US" sz="1238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Raw image- SW Actin                                                            </a:t>
            </a:r>
          </a:p>
          <a:p>
            <a:pPr defTabSz="514350">
              <a:defRPr/>
            </a:pPr>
            <a:r>
              <a:rPr lang="en-US" sz="1238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         </a:t>
            </a:r>
          </a:p>
          <a:p>
            <a:pPr defTabSz="514350">
              <a:defRPr/>
            </a:pPr>
            <a:r>
              <a:rPr lang="en-US" sz="1238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</a:p>
        </p:txBody>
      </p:sp>
    </p:spTree>
    <p:extLst>
      <p:ext uri="{BB962C8B-B14F-4D97-AF65-F5344CB8AC3E}">
        <p14:creationId xmlns:p14="http://schemas.microsoft.com/office/powerpoint/2010/main" val="1737173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46</Words>
  <Application>Microsoft Office PowerPoint</Application>
  <PresentationFormat>Widescreen</PresentationFormat>
  <Paragraphs>2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University of Michigan Health 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al, Rashi</dc:creator>
  <cp:lastModifiedBy>Dalal, Prarthana</cp:lastModifiedBy>
  <cp:revision>18</cp:revision>
  <dcterms:created xsi:type="dcterms:W3CDTF">2019-09-28T19:38:15Z</dcterms:created>
  <dcterms:modified xsi:type="dcterms:W3CDTF">2025-11-14T14:46:23Z</dcterms:modified>
</cp:coreProperties>
</file>